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23"/>
  </p:handoutMasterIdLst>
  <p:sldIdLst>
    <p:sldId id="282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76" r:id="rId13"/>
    <p:sldId id="277" r:id="rId14"/>
    <p:sldId id="266" r:id="rId15"/>
    <p:sldId id="267" r:id="rId16"/>
    <p:sldId id="268" r:id="rId17"/>
    <p:sldId id="278" r:id="rId18"/>
    <p:sldId id="269" r:id="rId19"/>
    <p:sldId id="279" r:id="rId20"/>
    <p:sldId id="280" r:id="rId21"/>
    <p:sldId id="281" r:id="rId2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2" d="100"/>
          <a:sy n="82" d="100"/>
        </p:scale>
        <p:origin x="-153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E3356E-23EC-4FC4-9F2B-09A003DC9172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61216B-F958-4D9A-ABA8-90C3599B41B5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8DAE8-DD3E-4A4E-AB80-8AAB55EA7C81}" type="datetimeFigureOut">
              <a:rPr lang="en-IN" smtClean="0"/>
              <a:pPr/>
              <a:t>05-12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2A6DA-6800-4B69-B5F6-6CE50CED0CB6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33400" y="1066800"/>
            <a:ext cx="7848600" cy="1752600"/>
          </a:xfrm>
        </p:spPr>
        <p:txBody>
          <a:bodyPr>
            <a:normAutofit fontScale="92500" lnSpcReduction="10000"/>
          </a:bodyPr>
          <a:lstStyle/>
          <a:p>
            <a:pPr algn="just"/>
            <a:r>
              <a:rPr lang="en-US" dirty="0" smtClean="0">
                <a:solidFill>
                  <a:schemeClr val="tx1"/>
                </a:solidFill>
              </a:rPr>
              <a:t>Fig S1: Segmental duplication of each chromosome of soybean. Length of segment (not to scale). Duplication in green </a:t>
            </a:r>
            <a:r>
              <a:rPr lang="en-US" dirty="0" err="1" smtClean="0">
                <a:solidFill>
                  <a:schemeClr val="tx1"/>
                </a:solidFill>
              </a:rPr>
              <a:t>colour</a:t>
            </a:r>
            <a:r>
              <a:rPr lang="en-US" dirty="0" smtClean="0">
                <a:solidFill>
                  <a:schemeClr val="tx1"/>
                </a:solidFill>
              </a:rPr>
              <a:t>- direct duplication; in red </a:t>
            </a:r>
            <a:r>
              <a:rPr lang="en-US" dirty="0" err="1" smtClean="0">
                <a:solidFill>
                  <a:schemeClr val="tx1"/>
                </a:solidFill>
              </a:rPr>
              <a:t>colour</a:t>
            </a:r>
            <a:r>
              <a:rPr lang="en-US" dirty="0" smtClean="0">
                <a:solidFill>
                  <a:schemeClr val="tx1"/>
                </a:solidFill>
              </a:rPr>
              <a:t>- reverse duplication</a:t>
            </a:r>
            <a:endParaRPr lang="en-IN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838200"/>
            <a:ext cx="1524000" cy="1219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438400"/>
            <a:ext cx="1524000" cy="685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5814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029200"/>
            <a:ext cx="1524000" cy="1066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343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4800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02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4114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581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857071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1091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5G2062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0045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9G0986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581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107500</a:t>
            </a:r>
          </a:p>
          <a:p>
            <a:r>
              <a:rPr lang="en-US" sz="1200" dirty="0" smtClean="0"/>
              <a:t>Glyma.07G0853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438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1767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6G2189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24200" y="51054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8G2628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8G2088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581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170200</a:t>
            </a:r>
          </a:p>
          <a:p>
            <a:r>
              <a:rPr lang="en-US" sz="1200" dirty="0" smtClean="0"/>
              <a:t>Glyma.09G1916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4338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199800</a:t>
            </a:r>
          </a:p>
          <a:p>
            <a:r>
              <a:rPr lang="en-US" sz="1200" dirty="0" smtClean="0"/>
              <a:t>Glyma.09G2114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004137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2338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9G2802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3124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438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4778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1271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9G1693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3434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124200" y="43828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022500</a:t>
            </a:r>
          </a:p>
          <a:p>
            <a:r>
              <a:rPr lang="en-US" sz="1200" dirty="0" smtClean="0"/>
              <a:t>Glyma.01G009600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1371600"/>
            <a:ext cx="1524000" cy="1066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667000"/>
            <a:ext cx="1524000" cy="759052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3886200"/>
            <a:ext cx="1524000" cy="2057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1371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3886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352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667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1371600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1207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3G1520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1371600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0G032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0G0670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048000" y="2710934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1987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2G1874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24200" y="3962400"/>
            <a:ext cx="1524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20G2351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20G0991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26670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0G0782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0G0864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38200" y="3962400"/>
            <a:ext cx="1524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0G153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0G2952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362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914400"/>
            <a:ext cx="1524000" cy="1219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438400"/>
            <a:ext cx="1524000" cy="11430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4267200"/>
            <a:ext cx="1524000" cy="1676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838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267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581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514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9144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2401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1G1772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8382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1G0034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1G0652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048000" y="2514600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2G0180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2G0639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24200" y="4309408"/>
            <a:ext cx="1524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8G0538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8G0036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2590800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1G091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1G1404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38200" y="4267200"/>
            <a:ext cx="1524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1G185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1G2534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914400"/>
            <a:ext cx="1524000" cy="1219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438400"/>
            <a:ext cx="1524000" cy="1143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4267200"/>
            <a:ext cx="1524000" cy="1676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1066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267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638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581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514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9144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1G091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1G1404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1066800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2G0180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2G0639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048000" y="2514600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308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6G2833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24200" y="4309408"/>
            <a:ext cx="1524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3153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3G2694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2590800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2G0960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2G1228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38200" y="4267200"/>
            <a:ext cx="152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2G185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2G2302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12192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24384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30480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805535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257800"/>
            <a:ext cx="1524000" cy="838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121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905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343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5105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257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4191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733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2514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12586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9G047500</a:t>
            </a:r>
          </a:p>
          <a:p>
            <a:endParaRPr lang="en-US" sz="1200" dirty="0"/>
          </a:p>
          <a:p>
            <a:r>
              <a:rPr lang="en-US" sz="1200" dirty="0" smtClean="0"/>
              <a:t>Glyma.19G0211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12586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045500</a:t>
            </a:r>
          </a:p>
          <a:p>
            <a:endParaRPr lang="en-US" sz="1200" dirty="0"/>
          </a:p>
          <a:p>
            <a:r>
              <a:rPr lang="en-US" sz="1200" dirty="0" smtClean="0"/>
              <a:t>Glyma.13G0640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24778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66600</a:t>
            </a:r>
          </a:p>
          <a:p>
            <a:r>
              <a:rPr lang="en-US" sz="1200" dirty="0" smtClean="0"/>
              <a:t>Glyma.17G0423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8055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104600</a:t>
            </a:r>
          </a:p>
          <a:p>
            <a:r>
              <a:rPr lang="en-US" sz="1200" dirty="0" smtClean="0"/>
              <a:t>Glyma.15G0579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30480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0G034300</a:t>
            </a:r>
          </a:p>
          <a:p>
            <a:r>
              <a:rPr lang="en-US" sz="1200" dirty="0" smtClean="0"/>
              <a:t>Glyma.10G0670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297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0452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5G0033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733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208300</a:t>
            </a:r>
          </a:p>
          <a:p>
            <a:r>
              <a:rPr lang="en-US" sz="1200" dirty="0" smtClean="0"/>
              <a:t>Glyma.13G2570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44196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2694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3G3153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2210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328500</a:t>
            </a:r>
          </a:p>
          <a:p>
            <a:endParaRPr lang="en-US" sz="1200" dirty="0"/>
          </a:p>
          <a:p>
            <a:r>
              <a:rPr lang="en-US" sz="1200" dirty="0" smtClean="0"/>
              <a:t>Glyma.13G3701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3505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971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3048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30435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120700</a:t>
            </a:r>
          </a:p>
          <a:p>
            <a:r>
              <a:rPr lang="en-US" sz="1200" dirty="0" smtClean="0"/>
              <a:t>Glyma.13G1520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25101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093800</a:t>
            </a:r>
          </a:p>
          <a:p>
            <a:r>
              <a:rPr lang="en-US" sz="1200" dirty="0" smtClean="0"/>
              <a:t>Glyma.13G1176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3434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048000" y="43828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2G2302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2G186200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6858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6002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2098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276600"/>
            <a:ext cx="1524000" cy="914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4419600"/>
            <a:ext cx="1524000" cy="1066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495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334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4114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200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67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725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311000</a:t>
            </a:r>
          </a:p>
          <a:p>
            <a:endParaRPr lang="en-US" sz="1200" dirty="0"/>
          </a:p>
          <a:p>
            <a:r>
              <a:rPr lang="en-US" sz="1200" dirty="0" smtClean="0"/>
              <a:t>Glyma.02G2941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001600</a:t>
            </a:r>
          </a:p>
          <a:p>
            <a:endParaRPr lang="en-US" sz="1200" dirty="0"/>
          </a:p>
          <a:p>
            <a:r>
              <a:rPr lang="en-US" sz="1200" dirty="0" smtClean="0"/>
              <a:t>Glyma.14G0201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6396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287700</a:t>
            </a:r>
          </a:p>
          <a:p>
            <a:r>
              <a:rPr lang="en-US" sz="1200" dirty="0" smtClean="0"/>
              <a:t>Glyma.02G2735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272135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2546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7G2155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261700</a:t>
            </a:r>
          </a:p>
          <a:p>
            <a:r>
              <a:rPr lang="en-US" sz="1200" dirty="0" smtClean="0"/>
              <a:t>Glyma.02G2649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44958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2223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2G2446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2766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0700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4G1124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4491335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 G1893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4G2145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743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056200</a:t>
            </a:r>
          </a:p>
          <a:p>
            <a:r>
              <a:rPr lang="en-US" sz="1200" dirty="0" smtClean="0"/>
              <a:t>Glyma.14G0581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671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027200</a:t>
            </a:r>
          </a:p>
          <a:p>
            <a:r>
              <a:rPr lang="en-US" sz="1200" dirty="0" smtClean="0"/>
              <a:t>Glyma.14G043900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8382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676400"/>
            <a:ext cx="1524000" cy="1447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181600"/>
            <a:ext cx="1524000" cy="838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4419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257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200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67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8776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370100</a:t>
            </a:r>
          </a:p>
          <a:p>
            <a:endParaRPr lang="en-US" sz="1200" dirty="0"/>
          </a:p>
          <a:p>
            <a:r>
              <a:rPr lang="en-US" sz="1200" dirty="0" smtClean="0"/>
              <a:t>Glyma.13G3285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003300</a:t>
            </a:r>
          </a:p>
          <a:p>
            <a:endParaRPr lang="en-US" sz="1200" dirty="0"/>
          </a:p>
          <a:p>
            <a:r>
              <a:rPr lang="en-US" sz="1200" dirty="0" smtClean="0"/>
              <a:t>Glyma.15G0452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663005"/>
            <a:ext cx="152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2570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3G2083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2210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148800</a:t>
            </a:r>
          </a:p>
          <a:p>
            <a:endParaRPr lang="en-US" sz="1200" dirty="0"/>
          </a:p>
          <a:p>
            <a:r>
              <a:rPr lang="en-US" sz="1200" dirty="0" smtClean="0"/>
              <a:t>Glyma.08G1545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2004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1091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5G2062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297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269100</a:t>
            </a:r>
          </a:p>
          <a:p>
            <a:endParaRPr lang="en-US" sz="1200" dirty="0"/>
          </a:p>
          <a:p>
            <a:r>
              <a:rPr lang="en-US" sz="1200" dirty="0" smtClean="0"/>
              <a:t>Glyma.15G2734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3048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990600" y="1671935"/>
            <a:ext cx="152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057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5G1046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3276600"/>
            <a:ext cx="1524000" cy="1219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124200" y="32766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0045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9G098600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1828800"/>
            <a:ext cx="1524000" cy="685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971800"/>
            <a:ext cx="1524000" cy="7620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4267200"/>
            <a:ext cx="1524000" cy="1295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1828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267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48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657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971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18288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9G1131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9G0940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906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0055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6G0290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3011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0531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2G0821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24200" y="4309408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1271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9G1693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022937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1332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6G1677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38200" y="42672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1767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6G2189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438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990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914400" y="1868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0400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6G132100</a:t>
            </a:r>
          </a:p>
        </p:txBody>
      </p:sp>
      <p:sp>
        <p:nvSpPr>
          <p:cNvPr id="27" name="Rounded Rectangle 26"/>
          <p:cNvSpPr/>
          <p:nvPr/>
        </p:nvSpPr>
        <p:spPr>
          <a:xfrm>
            <a:off x="3048000" y="914400"/>
            <a:ext cx="1524000" cy="7620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8" name="TextBox 27"/>
          <p:cNvSpPr txBox="1"/>
          <p:nvPr/>
        </p:nvSpPr>
        <p:spPr>
          <a:xfrm>
            <a:off x="3124200" y="9538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0362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7G060400</a:t>
            </a: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9144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5240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281535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7338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029200"/>
            <a:ext cx="1524000" cy="838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371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3733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4191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02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791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352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819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524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909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271900</a:t>
            </a:r>
          </a:p>
          <a:p>
            <a:r>
              <a:rPr lang="en-US" sz="1200" dirty="0" smtClean="0"/>
              <a:t>Glyma.07G2342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02200</a:t>
            </a:r>
          </a:p>
          <a:p>
            <a:r>
              <a:rPr lang="en-US" sz="1200" dirty="0" smtClean="0"/>
              <a:t>Glyma.17G0396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5240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117600</a:t>
            </a:r>
          </a:p>
          <a:p>
            <a:r>
              <a:rPr lang="en-US" sz="1200" dirty="0" smtClean="0"/>
              <a:t>Glyma.13G0938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733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044300</a:t>
            </a:r>
          </a:p>
          <a:p>
            <a:r>
              <a:rPr lang="en-US" sz="1200" dirty="0" smtClean="0"/>
              <a:t>Glyma.05G0702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2815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022700</a:t>
            </a:r>
          </a:p>
          <a:p>
            <a:r>
              <a:rPr lang="en-US" sz="1200" dirty="0" smtClean="0"/>
              <a:t>Glyma.05G0178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0292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1124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4G0700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28956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86300</a:t>
            </a:r>
          </a:p>
          <a:p>
            <a:r>
              <a:rPr lang="en-US" sz="1200" dirty="0" smtClean="0"/>
              <a:t>Glyma.17G1013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3733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126800</a:t>
            </a:r>
          </a:p>
          <a:p>
            <a:r>
              <a:rPr lang="en-US" sz="1200" dirty="0" smtClean="0"/>
              <a:t>Glyma.17G1528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004137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2155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7G2546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743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1981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76900</a:t>
            </a:r>
          </a:p>
          <a:p>
            <a:r>
              <a:rPr lang="en-US" sz="1200" dirty="0" smtClean="0"/>
              <a:t>Glyma.17G0821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5240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42300</a:t>
            </a:r>
          </a:p>
          <a:p>
            <a:r>
              <a:rPr lang="en-US" sz="1200" dirty="0" smtClean="0"/>
              <a:t>Glyma.17G0666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2672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124200" y="42672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115400</a:t>
            </a:r>
          </a:p>
          <a:p>
            <a:r>
              <a:rPr lang="en-US" sz="1200" dirty="0" smtClean="0"/>
              <a:t>Glyma.05G105600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762000" y="472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762000" y="4267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914400" y="42672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152800</a:t>
            </a:r>
          </a:p>
          <a:p>
            <a:r>
              <a:rPr lang="en-US" sz="1200" dirty="0" smtClean="0"/>
              <a:t>Glyma.17G160800</a:t>
            </a:r>
          </a:p>
        </p:txBody>
      </p:sp>
      <p:sp>
        <p:nvSpPr>
          <p:cNvPr id="44" name="Rounded Rectangle 43"/>
          <p:cNvSpPr/>
          <p:nvPr/>
        </p:nvSpPr>
        <p:spPr>
          <a:xfrm>
            <a:off x="3048000" y="28194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5" name="TextBox 44"/>
          <p:cNvSpPr txBox="1"/>
          <p:nvPr/>
        </p:nvSpPr>
        <p:spPr>
          <a:xfrm>
            <a:off x="3124200" y="2819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040500</a:t>
            </a:r>
          </a:p>
          <a:p>
            <a:r>
              <a:rPr lang="en-US" sz="1200" dirty="0" smtClean="0"/>
              <a:t>Glyma.05G025700</a:t>
            </a: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838200"/>
            <a:ext cx="1524000" cy="1219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2971800" y="3200400"/>
            <a:ext cx="1524000" cy="1219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2971800" y="4495800"/>
            <a:ext cx="1524000" cy="914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838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572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41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4495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200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8382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1G2534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1G1859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838200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8G0036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8G0538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048000" y="3251537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280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9G2338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4503003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2408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8G2575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251537"/>
            <a:ext cx="152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8G2088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18G2628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45720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8G2634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8G2818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6858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6002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2098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5814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029200"/>
            <a:ext cx="1524000" cy="1066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343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4800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02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4114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581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67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725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211400</a:t>
            </a:r>
          </a:p>
          <a:p>
            <a:endParaRPr lang="en-US" sz="1200" dirty="0"/>
          </a:p>
          <a:p>
            <a:r>
              <a:rPr lang="en-US" sz="1200" dirty="0" smtClean="0"/>
              <a:t>Glyma.09G1998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009600</a:t>
            </a:r>
          </a:p>
          <a:p>
            <a:endParaRPr lang="en-US" sz="1200" dirty="0"/>
          </a:p>
          <a:p>
            <a:r>
              <a:rPr lang="en-US" sz="1200" dirty="0" smtClean="0"/>
              <a:t>Glyma.01G0225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6396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041500</a:t>
            </a:r>
          </a:p>
          <a:p>
            <a:r>
              <a:rPr lang="en-US" sz="1200" dirty="0" smtClean="0"/>
              <a:t>Glyma.02G0189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581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067000</a:t>
            </a:r>
          </a:p>
          <a:p>
            <a:r>
              <a:rPr lang="en-US" sz="1200" dirty="0" smtClean="0"/>
              <a:t>Glyma.03G0709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105900</a:t>
            </a:r>
          </a:p>
          <a:p>
            <a:r>
              <a:rPr lang="en-US" sz="1200" dirty="0" smtClean="0"/>
              <a:t>Glyma.02G1261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1054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1G0652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1G0034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581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101400</a:t>
            </a:r>
          </a:p>
          <a:p>
            <a:r>
              <a:rPr lang="en-US" sz="1200" dirty="0" smtClean="0"/>
              <a:t>Glyma.01G1042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4338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133000</a:t>
            </a:r>
          </a:p>
          <a:p>
            <a:r>
              <a:rPr lang="en-US" sz="1200" dirty="0" smtClean="0"/>
              <a:t>Glyma.01G1439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004137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177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1G2401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743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045500</a:t>
            </a:r>
          </a:p>
          <a:p>
            <a:r>
              <a:rPr lang="en-US" sz="1200" dirty="0" smtClean="0"/>
              <a:t>Glyma.01G0693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671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023500</a:t>
            </a:r>
          </a:p>
          <a:p>
            <a:r>
              <a:rPr lang="en-US" sz="1200" dirty="0" smtClean="0"/>
              <a:t>Glyma.01G0448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3434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048000" y="43828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035200</a:t>
            </a:r>
          </a:p>
          <a:p>
            <a:r>
              <a:rPr lang="en-US" sz="1200" dirty="0" smtClean="0"/>
              <a:t>Glyma.03G023000</a:t>
            </a: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1143000"/>
            <a:ext cx="1524000" cy="914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2971800" y="2819400"/>
            <a:ext cx="1524000" cy="685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2971800" y="3886200"/>
            <a:ext cx="1524000" cy="1600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121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3886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41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505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819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1150203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3G0640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3G0455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1226403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9G0211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9G0475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048000" y="2870537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0545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6G0400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3886201"/>
            <a:ext cx="1524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128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3G2637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2819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9G0940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19G1131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3886200"/>
            <a:ext cx="1524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9G130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9G2627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990600"/>
            <a:ext cx="1524000" cy="914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2819400"/>
            <a:ext cx="1524000" cy="2667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90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48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819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997803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2095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7G2356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906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20G0098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20G0420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2819400"/>
            <a:ext cx="152400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0G296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0G1532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2819400"/>
            <a:ext cx="152400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20G0991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20G2351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1905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6858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600200"/>
            <a:ext cx="1524000" cy="533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2098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5814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5626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371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648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5105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181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962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429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447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725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044800</a:t>
            </a:r>
          </a:p>
          <a:p>
            <a:endParaRPr lang="en-US" sz="1200" dirty="0"/>
          </a:p>
          <a:p>
            <a:r>
              <a:rPr lang="en-US" sz="1200" dirty="0" smtClean="0"/>
              <a:t>Glyma.01G0235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018900</a:t>
            </a:r>
          </a:p>
          <a:p>
            <a:r>
              <a:rPr lang="en-US" sz="1200" dirty="0" smtClean="0"/>
              <a:t>Glyma.02G0415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6396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133200</a:t>
            </a:r>
          </a:p>
          <a:p>
            <a:r>
              <a:rPr lang="en-US" sz="1200" dirty="0" smtClean="0"/>
              <a:t>Glyma.16G1676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5814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189300</a:t>
            </a:r>
          </a:p>
          <a:p>
            <a:r>
              <a:rPr lang="en-US" sz="1200" dirty="0" smtClean="0"/>
              <a:t>Glyma.14G2145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045500</a:t>
            </a:r>
          </a:p>
          <a:p>
            <a:r>
              <a:rPr lang="en-US" sz="1200" dirty="0" smtClean="0"/>
              <a:t>Glyma.01G0693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5581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020100</a:t>
            </a:r>
            <a:endParaRPr lang="en-US" sz="1200" dirty="0"/>
          </a:p>
          <a:p>
            <a:r>
              <a:rPr lang="en-US" sz="1200" dirty="0" smtClean="0"/>
              <a:t>Glyma.14G0016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4290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222300</a:t>
            </a:r>
          </a:p>
          <a:p>
            <a:r>
              <a:rPr lang="en-US" sz="1200" dirty="0" smtClean="0"/>
              <a:t>Glyma.02G2446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46437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273500</a:t>
            </a:r>
          </a:p>
          <a:p>
            <a:r>
              <a:rPr lang="en-US" sz="1200" dirty="0" smtClean="0"/>
              <a:t>Glyma.02G2877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2210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2941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2G3110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743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1828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105900</a:t>
            </a:r>
          </a:p>
          <a:p>
            <a:r>
              <a:rPr lang="en-US" sz="1200" dirty="0" smtClean="0"/>
              <a:t>Glyma.02G1261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447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053100</a:t>
            </a:r>
          </a:p>
          <a:p>
            <a:r>
              <a:rPr lang="en-US" sz="1200" dirty="0" smtClean="0"/>
              <a:t>Glyma.02G0821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343400"/>
            <a:ext cx="1524000" cy="533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048000" y="43828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056200</a:t>
            </a:r>
          </a:p>
          <a:p>
            <a:r>
              <a:rPr lang="en-US" sz="1200" dirty="0" smtClean="0"/>
              <a:t>Glyma.14G058100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762000" y="4572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762000" y="4114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762000" y="3352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762000" y="2895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990600" y="28911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187400</a:t>
            </a:r>
          </a:p>
          <a:p>
            <a:r>
              <a:rPr lang="en-US" sz="1200" dirty="0" smtClean="0"/>
              <a:t>Glyma.02G198700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914400" y="41103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2G261700</a:t>
            </a:r>
          </a:p>
          <a:p>
            <a:r>
              <a:rPr lang="en-US" sz="1200" dirty="0" smtClean="0"/>
              <a:t>Glyma.02G264900</a:t>
            </a:r>
          </a:p>
        </p:txBody>
      </p:sp>
      <p:sp>
        <p:nvSpPr>
          <p:cNvPr id="47" name="Rounded Rectangle 46"/>
          <p:cNvSpPr/>
          <p:nvPr/>
        </p:nvSpPr>
        <p:spPr>
          <a:xfrm>
            <a:off x="3048000" y="27432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8" name="TextBox 47"/>
          <p:cNvSpPr txBox="1"/>
          <p:nvPr/>
        </p:nvSpPr>
        <p:spPr>
          <a:xfrm>
            <a:off x="3124200" y="27432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0G085600</a:t>
            </a:r>
          </a:p>
          <a:p>
            <a:r>
              <a:rPr lang="en-US" sz="1200" dirty="0" smtClean="0"/>
              <a:t>Glyma.10G078200</a:t>
            </a:r>
          </a:p>
        </p:txBody>
      </p:sp>
      <p:sp>
        <p:nvSpPr>
          <p:cNvPr id="49" name="Rounded Rectangle 48"/>
          <p:cNvSpPr/>
          <p:nvPr/>
        </p:nvSpPr>
        <p:spPr>
          <a:xfrm>
            <a:off x="3048000" y="5024735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0" name="TextBox 49"/>
          <p:cNvSpPr txBox="1"/>
          <p:nvPr/>
        </p:nvSpPr>
        <p:spPr>
          <a:xfrm>
            <a:off x="3124200" y="50247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4G043900</a:t>
            </a:r>
          </a:p>
          <a:p>
            <a:r>
              <a:rPr lang="en-US" sz="1200" dirty="0" smtClean="0"/>
              <a:t>Glyma.14G027200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4572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8382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828800"/>
            <a:ext cx="1524000" cy="533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3119734"/>
            <a:ext cx="1524000" cy="690265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4114800"/>
            <a:ext cx="1524000" cy="1447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562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4114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905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8776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143900</a:t>
            </a:r>
          </a:p>
          <a:p>
            <a:endParaRPr lang="en-US" sz="1200" dirty="0"/>
          </a:p>
          <a:p>
            <a:r>
              <a:rPr lang="en-US" sz="1200" dirty="0" smtClean="0"/>
              <a:t>Glyma.01G1330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023000</a:t>
            </a:r>
          </a:p>
          <a:p>
            <a:endParaRPr lang="en-US" sz="1200" dirty="0"/>
          </a:p>
          <a:p>
            <a:r>
              <a:rPr lang="en-US" sz="1200" dirty="0" smtClean="0"/>
              <a:t>Glyma.03G0352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8682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1G101400</a:t>
            </a:r>
          </a:p>
          <a:p>
            <a:r>
              <a:rPr lang="en-US" sz="1200" dirty="0" smtClean="0"/>
              <a:t>Glyma.01G1042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3119735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1176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7G1089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24200" y="4191000"/>
            <a:ext cx="152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9G130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9G2627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4177605"/>
            <a:ext cx="152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128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3G2637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3810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362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3048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30874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1016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3G1181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9005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067000</a:t>
            </a:r>
          </a:p>
          <a:p>
            <a:r>
              <a:rPr lang="en-US" sz="1200" dirty="0" smtClean="0"/>
              <a:t>Glyma.03G070900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914400"/>
            <a:ext cx="1524000" cy="685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1752600"/>
            <a:ext cx="1524000" cy="914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2895600"/>
            <a:ext cx="1524000" cy="685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4953000"/>
            <a:ext cx="1524000" cy="1066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4800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02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791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810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67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9538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000400</a:t>
            </a:r>
          </a:p>
          <a:p>
            <a:endParaRPr lang="en-US" sz="1200" dirty="0"/>
          </a:p>
          <a:p>
            <a:r>
              <a:rPr lang="en-US" sz="1200" dirty="0" smtClean="0"/>
              <a:t>Glyma.06G0421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000600</a:t>
            </a:r>
          </a:p>
          <a:p>
            <a:endParaRPr lang="en-US" sz="1200" dirty="0"/>
          </a:p>
          <a:p>
            <a:r>
              <a:rPr lang="en-US" sz="1200" dirty="0" smtClean="0"/>
              <a:t>Glyma.04G0412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28956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2064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6G1818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18288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0492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6G1065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0292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1426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6G1108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817203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186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4G2218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004137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2227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4G2519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3505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667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895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8588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1588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4G1842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671935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047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4G1064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3810000"/>
            <a:ext cx="1524000" cy="9906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048000" y="3849469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1789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6G143600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6858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6002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2098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5052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029200"/>
            <a:ext cx="1524000" cy="1066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038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4800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02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962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505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67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725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82100</a:t>
            </a:r>
          </a:p>
          <a:p>
            <a:endParaRPr lang="en-US" sz="1200" dirty="0"/>
          </a:p>
          <a:p>
            <a:r>
              <a:rPr lang="en-US" sz="1200" dirty="0" smtClean="0"/>
              <a:t>Glyma.17G0769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017800</a:t>
            </a:r>
          </a:p>
          <a:p>
            <a:endParaRPr lang="en-US" sz="1200" dirty="0"/>
          </a:p>
          <a:p>
            <a:r>
              <a:rPr lang="en-US" sz="1200" dirty="0" smtClean="0"/>
              <a:t>Glyma.05G0227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6396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86300</a:t>
            </a:r>
          </a:p>
          <a:p>
            <a:r>
              <a:rPr lang="en-US" sz="1200" dirty="0" smtClean="0"/>
              <a:t>Glyma.17G1013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5052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072100</a:t>
            </a:r>
          </a:p>
          <a:p>
            <a:r>
              <a:rPr lang="en-US" sz="1200" dirty="0" smtClean="0"/>
              <a:t>Glyma.08G0824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126800</a:t>
            </a:r>
          </a:p>
          <a:p>
            <a:r>
              <a:rPr lang="en-US" sz="1200" dirty="0" smtClean="0"/>
              <a:t>Glyma.17G1528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1054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0078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8G0574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50292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2004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5G2488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35007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117000</a:t>
            </a:r>
          </a:p>
          <a:p>
            <a:r>
              <a:rPr lang="en-US" sz="1200" dirty="0" smtClean="0"/>
              <a:t>Glyma.05G1276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40386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1370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5G1845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743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2098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044300</a:t>
            </a:r>
          </a:p>
          <a:p>
            <a:r>
              <a:rPr lang="en-US" sz="1200" dirty="0" smtClean="0"/>
              <a:t>Glyma.05G0702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671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025700</a:t>
            </a:r>
          </a:p>
          <a:p>
            <a:r>
              <a:rPr lang="en-US" sz="1200" dirty="0" smtClean="0"/>
              <a:t>Glyma.05G0405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038600"/>
            <a:ext cx="1524000" cy="838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124200" y="40386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0923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8G142400</a:t>
            </a:r>
          </a:p>
        </p:txBody>
      </p:sp>
      <p:sp>
        <p:nvSpPr>
          <p:cNvPr id="36" name="Rounded Rectangle 35"/>
          <p:cNvSpPr/>
          <p:nvPr/>
        </p:nvSpPr>
        <p:spPr>
          <a:xfrm>
            <a:off x="3048000" y="28956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0" name="TextBox 39"/>
          <p:cNvSpPr txBox="1"/>
          <p:nvPr/>
        </p:nvSpPr>
        <p:spPr>
          <a:xfrm>
            <a:off x="3124200" y="28956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160800</a:t>
            </a:r>
          </a:p>
          <a:p>
            <a:r>
              <a:rPr lang="en-US" sz="1200" dirty="0" smtClean="0"/>
              <a:t>Glyma.17G152800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762000" y="3429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762000" y="2895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914400" y="28956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105600</a:t>
            </a:r>
          </a:p>
          <a:p>
            <a:r>
              <a:rPr lang="en-US" sz="1200" dirty="0" smtClean="0"/>
              <a:t>Glyma.05G115400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685800"/>
            <a:ext cx="1524000" cy="685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524000"/>
            <a:ext cx="1524000" cy="6096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209800"/>
            <a:ext cx="1524000" cy="6096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2971800"/>
            <a:ext cx="1524000" cy="685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4953000"/>
            <a:ext cx="1524000" cy="10668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838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447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3886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4648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4953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94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657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2971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524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7252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0006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4G0412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8382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000400</a:t>
            </a:r>
          </a:p>
          <a:p>
            <a:endParaRPr lang="en-US" sz="1200" dirty="0"/>
          </a:p>
          <a:p>
            <a:r>
              <a:rPr lang="en-US" sz="1200" dirty="0" smtClean="0"/>
              <a:t>Glyma.06G0421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5240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0479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4G1064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29718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2218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4G1869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2098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2519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4G2227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0292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2G1228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2G0960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29718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1436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6G1789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3962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1818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6G2064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004137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2833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06G3089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819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133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14400" y="21730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1108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6G1426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14400" y="15240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6G0492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6G1065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38862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048000" y="39256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4G1842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4G158800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838200"/>
            <a:ext cx="1524000" cy="762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6764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209800"/>
            <a:ext cx="1524000" cy="838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119734"/>
            <a:ext cx="1524000" cy="537865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105400"/>
            <a:ext cx="1524000" cy="838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343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5029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105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791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657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124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676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8776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220800</a:t>
            </a:r>
          </a:p>
          <a:p>
            <a:endParaRPr lang="en-US" sz="1200" dirty="0"/>
          </a:p>
          <a:p>
            <a:r>
              <a:rPr lang="en-US" sz="1200" dirty="0" smtClean="0"/>
              <a:t>Glyma.08G2116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021000</a:t>
            </a:r>
          </a:p>
          <a:p>
            <a:endParaRPr lang="en-US" sz="1200" dirty="0"/>
          </a:p>
          <a:p>
            <a:r>
              <a:rPr lang="en-US" sz="1200" dirty="0" smtClean="0"/>
              <a:t>Glyma.07G0312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671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6G005500</a:t>
            </a:r>
          </a:p>
          <a:p>
            <a:r>
              <a:rPr lang="en-US" sz="1200" dirty="0" smtClean="0"/>
              <a:t>Glyma.16G0290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1197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3G118100</a:t>
            </a:r>
          </a:p>
          <a:p>
            <a:r>
              <a:rPr lang="en-US" sz="1200" dirty="0" smtClean="0"/>
              <a:t>Glyma.03G1016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2098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9G1916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9G1702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24200" y="51054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7G037500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Glyma.17G0022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90600" y="3195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108900</a:t>
            </a:r>
          </a:p>
          <a:p>
            <a:r>
              <a:rPr lang="en-US" sz="1200" dirty="0" smtClean="0"/>
              <a:t>Glyma.07G1176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4338935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2095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07G2356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105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235900</a:t>
            </a:r>
          </a:p>
          <a:p>
            <a:endParaRPr lang="en-US" sz="1200" dirty="0"/>
          </a:p>
          <a:p>
            <a:r>
              <a:rPr lang="en-US" sz="1200" dirty="0" smtClean="0"/>
              <a:t>Glyma.07G2719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2971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057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2098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0853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7G1075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671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036200</a:t>
            </a:r>
          </a:p>
          <a:p>
            <a:r>
              <a:rPr lang="en-US" sz="1200" dirty="0" smtClean="0"/>
              <a:t>Glyma.07G0604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343400"/>
            <a:ext cx="1524000" cy="6858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124200" y="43828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20G009800</a:t>
            </a:r>
          </a:p>
          <a:p>
            <a:endParaRPr lang="en-US" sz="1200" dirty="0" smtClean="0"/>
          </a:p>
          <a:p>
            <a:r>
              <a:rPr lang="en-US" sz="1200" dirty="0" smtClean="0"/>
              <a:t>Glyma.20G042000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762000" y="685800"/>
            <a:ext cx="1676400" cy="5410200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ounded Rectangle 4"/>
          <p:cNvSpPr/>
          <p:nvPr/>
        </p:nvSpPr>
        <p:spPr>
          <a:xfrm>
            <a:off x="3048000" y="838200"/>
            <a:ext cx="1524000" cy="7620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ounded Rectangle 7"/>
          <p:cNvSpPr/>
          <p:nvPr/>
        </p:nvSpPr>
        <p:spPr>
          <a:xfrm>
            <a:off x="3048000" y="1752600"/>
            <a:ext cx="1524000" cy="5334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ounded Rectangle 8"/>
          <p:cNvSpPr/>
          <p:nvPr/>
        </p:nvSpPr>
        <p:spPr>
          <a:xfrm>
            <a:off x="3048000" y="2611740"/>
            <a:ext cx="1524000" cy="81726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ounded Rectangle 9"/>
          <p:cNvSpPr/>
          <p:nvPr/>
        </p:nvSpPr>
        <p:spPr>
          <a:xfrm>
            <a:off x="3048000" y="3505200"/>
            <a:ext cx="1524000" cy="457200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Rounded Rectangle 10"/>
          <p:cNvSpPr/>
          <p:nvPr/>
        </p:nvSpPr>
        <p:spPr>
          <a:xfrm>
            <a:off x="3048000" y="5334000"/>
            <a:ext cx="1524000" cy="4572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3" name="Straight Connector 12"/>
          <p:cNvCxnSpPr/>
          <p:nvPr/>
        </p:nvCxnSpPr>
        <p:spPr>
          <a:xfrm>
            <a:off x="762000" y="91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2000" y="1600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62000" y="4724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62000" y="5181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62000" y="5334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62000" y="5791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62000" y="39624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62000" y="35052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2000" y="17526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124200" y="877669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200400</a:t>
            </a:r>
          </a:p>
          <a:p>
            <a:endParaRPr lang="en-US" sz="1200" dirty="0"/>
          </a:p>
          <a:p>
            <a:r>
              <a:rPr lang="en-US" sz="1200" dirty="0" smtClean="0"/>
              <a:t>Glyma.05G2488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14400" y="914400"/>
            <a:ext cx="152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007800</a:t>
            </a:r>
          </a:p>
          <a:p>
            <a:endParaRPr lang="en-US" sz="1200" dirty="0"/>
          </a:p>
          <a:p>
            <a:r>
              <a:rPr lang="en-US" sz="1200" dirty="0" smtClean="0"/>
              <a:t>Glyma.08G05740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24200" y="17920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117000</a:t>
            </a:r>
          </a:p>
          <a:p>
            <a:r>
              <a:rPr lang="en-US" sz="1200" dirty="0" smtClean="0"/>
              <a:t>Glyma.05G12760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4200" y="35052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5G269100</a:t>
            </a:r>
          </a:p>
          <a:p>
            <a:r>
              <a:rPr lang="en-US" sz="1200" dirty="0" smtClean="0"/>
              <a:t>Glyma.15G2734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24200" y="25908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5G1370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5G1845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048000" y="5329535"/>
            <a:ext cx="1524000" cy="461665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18G263400</a:t>
            </a:r>
            <a:endParaRPr lang="en-US" sz="1200" dirty="0"/>
          </a:p>
          <a:p>
            <a:r>
              <a:rPr lang="en-US" sz="1200" dirty="0" smtClean="0"/>
              <a:t>Glyma.18G2818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14400" y="3505200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148800</a:t>
            </a:r>
          </a:p>
          <a:p>
            <a:r>
              <a:rPr lang="en-US" sz="1200" dirty="0" smtClean="0"/>
              <a:t>Glyma.08G15450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14400" y="47199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211600</a:t>
            </a:r>
          </a:p>
          <a:p>
            <a:r>
              <a:rPr lang="en-US" sz="1200" dirty="0" smtClean="0"/>
              <a:t>Glyma.08G2208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14400" y="53295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240800</a:t>
            </a:r>
            <a:endParaRPr lang="en-US" sz="1200" dirty="0"/>
          </a:p>
          <a:p>
            <a:r>
              <a:rPr lang="en-US" sz="1200" dirty="0" smtClean="0"/>
              <a:t>Glyma.08G257500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62000" y="34290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62000" y="2209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62000" y="2590800"/>
            <a:ext cx="167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90600" y="2590800"/>
            <a:ext cx="152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092300</a:t>
            </a:r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Glyma.08G1424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90600" y="1748135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8G072100</a:t>
            </a:r>
          </a:p>
          <a:p>
            <a:r>
              <a:rPr lang="en-US" sz="1200" dirty="0" smtClean="0"/>
              <a:t>Glyma.08G082400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3048000" y="4724400"/>
            <a:ext cx="1524000" cy="5334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2" name="TextBox 41"/>
          <p:cNvSpPr txBox="1"/>
          <p:nvPr/>
        </p:nvSpPr>
        <p:spPr>
          <a:xfrm>
            <a:off x="3048000" y="4763869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lyma.07G031200</a:t>
            </a:r>
          </a:p>
          <a:p>
            <a:r>
              <a:rPr lang="en-US" sz="1200" dirty="0" smtClean="0"/>
              <a:t>Glyma.07G021000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6</TotalTime>
  <Words>416</Words>
  <Application>Microsoft Office PowerPoint</Application>
  <PresentationFormat>On-screen Show (4:3)</PresentationFormat>
  <Paragraphs>677</Paragraphs>
  <Slides>2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2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SR Indore</dc:creator>
  <cp:lastModifiedBy>DSR Indore</cp:lastModifiedBy>
  <cp:revision>55</cp:revision>
  <dcterms:created xsi:type="dcterms:W3CDTF">2020-11-10T04:32:55Z</dcterms:created>
  <dcterms:modified xsi:type="dcterms:W3CDTF">2020-12-05T09:40:02Z</dcterms:modified>
</cp:coreProperties>
</file>